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35.xml" ContentType="application/vnd.openxmlformats-officedocument.presentationml.notesSlide+xml"/>
  <Override PartName="/ppt/notesSlides/notesSlide36.xml" ContentType="application/vnd.openxmlformats-officedocument.presentationml.notesSlide+xml"/>
  <Override PartName="/ppt/notesSlides/notesSlide37.xml" ContentType="application/vnd.openxmlformats-officedocument.presentationml.notesSlide+xml"/>
  <Override PartName="/ppt/notesSlides/notesSlide38.xml" ContentType="application/vnd.openxmlformats-officedocument.presentationml.notesSlide+xml"/>
  <Override PartName="/ppt/notesSlides/notesSlide39.xml" ContentType="application/vnd.openxmlformats-officedocument.presentationml.notesSlide+xml"/>
  <Override PartName="/ppt/notesSlides/notesSlide40.xml" ContentType="application/vnd.openxmlformats-officedocument.presentationml.notesSlide+xml"/>
  <Override PartName="/ppt/notesSlides/notesSlide41.xml" ContentType="application/vnd.openxmlformats-officedocument.presentationml.notesSlide+xml"/>
  <Override PartName="/ppt/notesSlides/notesSlide42.xml" ContentType="application/vnd.openxmlformats-officedocument.presentationml.notesSlide+xml"/>
  <Override PartName="/ppt/notesSlides/notesSlide43.xml" ContentType="application/vnd.openxmlformats-officedocument.presentationml.notesSlide+xml"/>
  <Override PartName="/ppt/notesSlides/notesSlide44.xml" ContentType="application/vnd.openxmlformats-officedocument.presentationml.notesSlide+xml"/>
  <Override PartName="/ppt/notesSlides/notesSlide45.xml" ContentType="application/vnd.openxmlformats-officedocument.presentationml.notesSlide+xml"/>
  <Override PartName="/ppt/notesSlides/notesSlide46.xml" ContentType="application/vnd.openxmlformats-officedocument.presentationml.notesSlide+xml"/>
  <Override PartName="/ppt/notesSlides/notesSlide47.xml" ContentType="application/vnd.openxmlformats-officedocument.presentationml.notesSlide+xml"/>
  <Override PartName="/ppt/notesSlides/notesSlide48.xml" ContentType="application/vnd.openxmlformats-officedocument.presentationml.notesSlide+xml"/>
  <Override PartName="/ppt/notesSlides/notesSlide49.xml" ContentType="application/vnd.openxmlformats-officedocument.presentationml.notesSlide+xml"/>
  <Override PartName="/ppt/notesSlides/notesSlide50.xml" ContentType="application/vnd.openxmlformats-officedocument.presentationml.notesSlide+xml"/>
  <Override PartName="/ppt/notesSlides/notesSlide51.xml" ContentType="application/vnd.openxmlformats-officedocument.presentationml.notesSlide+xml"/>
  <Override PartName="/ppt/notesSlides/notesSlide52.xml" ContentType="application/vnd.openxmlformats-officedocument.presentationml.notesSlide+xml"/>
  <Override PartName="/ppt/notesSlides/notesSlide53.xml" ContentType="application/vnd.openxmlformats-officedocument.presentationml.notesSlide+xml"/>
  <Override PartName="/ppt/notesSlides/notesSlide54.xml" ContentType="application/vnd.openxmlformats-officedocument.presentationml.notesSlide+xml"/>
  <Override PartName="/ppt/notesSlides/notesSlide55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7"/>
  </p:notesMasterIdLst>
  <p:sldIdLst>
    <p:sldId id="267" r:id="rId2"/>
    <p:sldId id="257" r:id="rId3"/>
    <p:sldId id="270" r:id="rId4"/>
    <p:sldId id="310" r:id="rId5"/>
    <p:sldId id="316" r:id="rId6"/>
    <p:sldId id="297" r:id="rId7"/>
    <p:sldId id="298" r:id="rId8"/>
    <p:sldId id="322" r:id="rId9"/>
    <p:sldId id="272" r:id="rId10"/>
    <p:sldId id="323" r:id="rId11"/>
    <p:sldId id="273" r:id="rId12"/>
    <p:sldId id="274" r:id="rId13"/>
    <p:sldId id="317" r:id="rId14"/>
    <p:sldId id="275" r:id="rId15"/>
    <p:sldId id="300" r:id="rId16"/>
    <p:sldId id="324" r:id="rId17"/>
    <p:sldId id="301" r:id="rId18"/>
    <p:sldId id="277" r:id="rId19"/>
    <p:sldId id="276" r:id="rId20"/>
    <p:sldId id="311" r:id="rId21"/>
    <p:sldId id="318" r:id="rId22"/>
    <p:sldId id="314" r:id="rId23"/>
    <p:sldId id="325" r:id="rId24"/>
    <p:sldId id="279" r:id="rId25"/>
    <p:sldId id="280" r:id="rId26"/>
    <p:sldId id="302" r:id="rId27"/>
    <p:sldId id="319" r:id="rId28"/>
    <p:sldId id="326" r:id="rId29"/>
    <p:sldId id="282" r:id="rId30"/>
    <p:sldId id="283" r:id="rId31"/>
    <p:sldId id="303" r:id="rId32"/>
    <p:sldId id="320" r:id="rId33"/>
    <p:sldId id="327" r:id="rId34"/>
    <p:sldId id="285" r:id="rId35"/>
    <p:sldId id="286" r:id="rId36"/>
    <p:sldId id="304" r:id="rId37"/>
    <p:sldId id="321" r:id="rId38"/>
    <p:sldId id="328" r:id="rId39"/>
    <p:sldId id="309" r:id="rId40"/>
    <p:sldId id="313" r:id="rId41"/>
    <p:sldId id="290" r:id="rId42"/>
    <p:sldId id="329" r:id="rId43"/>
    <p:sldId id="291" r:id="rId44"/>
    <p:sldId id="292" r:id="rId45"/>
    <p:sldId id="312" r:id="rId46"/>
    <p:sldId id="294" r:id="rId47"/>
    <p:sldId id="293" r:id="rId48"/>
    <p:sldId id="330" r:id="rId49"/>
    <p:sldId id="266" r:id="rId50"/>
    <p:sldId id="295" r:id="rId51"/>
    <p:sldId id="305" r:id="rId52"/>
    <p:sldId id="306" r:id="rId53"/>
    <p:sldId id="307" r:id="rId54"/>
    <p:sldId id="308" r:id="rId55"/>
    <p:sldId id="296" r:id="rId5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41ECB3B-3D4C-463C-A1A1-3B4FFE0D6F3A}" v="69" dt="2025-11-07T01:51:37.49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31" autoAdjust="0"/>
    <p:restoredTop sz="89396" autoAdjust="0"/>
  </p:normalViewPr>
  <p:slideViewPr>
    <p:cSldViewPr snapToGrid="0">
      <p:cViewPr varScale="1">
        <p:scale>
          <a:sx n="72" d="100"/>
          <a:sy n="72" d="100"/>
        </p:scale>
        <p:origin x="40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63" Type="http://schemas.microsoft.com/office/2015/10/relationships/revisionInfo" Target="revisionInfo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presProps" Target="presProps.xml"/><Relationship Id="rId5" Type="http://schemas.openxmlformats.org/officeDocument/2006/relationships/slide" Target="slides/slide4.xml"/><Relationship Id="rId61" Type="http://schemas.openxmlformats.org/officeDocument/2006/relationships/tableStyles" Target="tableStyles.xml"/><Relationship Id="rId19" Type="http://schemas.openxmlformats.org/officeDocument/2006/relationships/slide" Target="slides/slide1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viewProps" Target="viewProps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亮太 松井" userId="b1607756e1acfed1" providerId="LiveId" clId="{0A77853B-A9AC-43A6-80F5-B68EFB7CB51C}"/>
    <pc:docChg chg="addSld modSld">
      <pc:chgData name="亮太 松井" userId="b1607756e1acfed1" providerId="LiveId" clId="{0A77853B-A9AC-43A6-80F5-B68EFB7CB51C}" dt="2025-11-07T01:52:14.897" v="442" actId="14100"/>
      <pc:docMkLst>
        <pc:docMk/>
      </pc:docMkLst>
      <pc:sldChg chg="modSp mod">
        <pc:chgData name="亮太 松井" userId="b1607756e1acfed1" providerId="LiveId" clId="{0A77853B-A9AC-43A6-80F5-B68EFB7CB51C}" dt="2025-11-07T01:41:05.583" v="37" actId="14100"/>
        <pc:sldMkLst>
          <pc:docMk/>
          <pc:sldMk cId="1337238847" sldId="272"/>
        </pc:sldMkLst>
        <pc:spChg chg="mod">
          <ac:chgData name="亮太 松井" userId="b1607756e1acfed1" providerId="LiveId" clId="{0A77853B-A9AC-43A6-80F5-B68EFB7CB51C}" dt="2025-11-07T01:41:05.583" v="37" actId="14100"/>
          <ac:spMkLst>
            <pc:docMk/>
            <pc:sldMk cId="1337238847" sldId="272"/>
            <ac:spMk id="4" creationId="{3667F319-9233-8D55-4A27-BA840A83507E}"/>
          </ac:spMkLst>
        </pc:spChg>
      </pc:sldChg>
      <pc:sldChg chg="addSp modSp new mod modNotesTx">
        <pc:chgData name="亮太 松井" userId="b1607756e1acfed1" providerId="LiveId" clId="{0A77853B-A9AC-43A6-80F5-B68EFB7CB51C}" dt="2025-11-07T01:40:30.026" v="31" actId="20577"/>
        <pc:sldMkLst>
          <pc:docMk/>
          <pc:sldMk cId="1984854236" sldId="322"/>
        </pc:sldMkLst>
        <pc:spChg chg="add mod">
          <ac:chgData name="亮太 松井" userId="b1607756e1acfed1" providerId="LiveId" clId="{0A77853B-A9AC-43A6-80F5-B68EFB7CB51C}" dt="2025-11-07T01:40:10.937" v="6" actId="20577"/>
          <ac:spMkLst>
            <pc:docMk/>
            <pc:sldMk cId="1984854236" sldId="322"/>
            <ac:spMk id="4" creationId="{16C4E97E-8068-59D6-EE06-17B667DA5FDE}"/>
          </ac:spMkLst>
        </pc:spChg>
        <pc:picChg chg="add mod">
          <ac:chgData name="亮太 松井" userId="b1607756e1acfed1" providerId="LiveId" clId="{0A77853B-A9AC-43A6-80F5-B68EFB7CB51C}" dt="2025-11-07T01:40:19.576" v="12" actId="1037"/>
          <ac:picMkLst>
            <pc:docMk/>
            <pc:sldMk cId="1984854236" sldId="322"/>
            <ac:picMk id="3" creationId="{F0C570F3-C78C-6443-0460-81EFB6F46334}"/>
          </ac:picMkLst>
        </pc:picChg>
      </pc:sldChg>
      <pc:sldChg chg="addSp modSp new mod modNotesTx">
        <pc:chgData name="亮太 松井" userId="b1607756e1acfed1" providerId="LiveId" clId="{0A77853B-A9AC-43A6-80F5-B68EFB7CB51C}" dt="2025-11-07T01:41:51.506" v="63" actId="20577"/>
        <pc:sldMkLst>
          <pc:docMk/>
          <pc:sldMk cId="192411029" sldId="323"/>
        </pc:sldMkLst>
        <pc:spChg chg="add mod">
          <ac:chgData name="亮太 松井" userId="b1607756e1acfed1" providerId="LiveId" clId="{0A77853B-A9AC-43A6-80F5-B68EFB7CB51C}" dt="2025-11-07T01:41:12.550" v="40" actId="20577"/>
          <ac:spMkLst>
            <pc:docMk/>
            <pc:sldMk cId="192411029" sldId="323"/>
            <ac:spMk id="2" creationId="{2268BA12-B16C-16D1-9C3C-236F6A797214}"/>
          </ac:spMkLst>
        </pc:spChg>
        <pc:picChg chg="add mod">
          <ac:chgData name="亮太 松井" userId="b1607756e1acfed1" providerId="LiveId" clId="{0A77853B-A9AC-43A6-80F5-B68EFB7CB51C}" dt="2025-11-07T01:41:42.755" v="43" actId="14100"/>
          <ac:picMkLst>
            <pc:docMk/>
            <pc:sldMk cId="192411029" sldId="323"/>
            <ac:picMk id="4" creationId="{66312498-AC92-A717-80D7-234DD8A1F106}"/>
          </ac:picMkLst>
        </pc:picChg>
      </pc:sldChg>
      <pc:sldChg chg="addSp modSp new mod modNotesTx">
        <pc:chgData name="亮太 松井" userId="b1607756e1acfed1" providerId="LiveId" clId="{0A77853B-A9AC-43A6-80F5-B68EFB7CB51C}" dt="2025-11-07T01:43:40.402" v="124" actId="20577"/>
        <pc:sldMkLst>
          <pc:docMk/>
          <pc:sldMk cId="906878716" sldId="324"/>
        </pc:sldMkLst>
        <pc:spChg chg="add mod">
          <ac:chgData name="亮太 松井" userId="b1607756e1acfed1" providerId="LiveId" clId="{0A77853B-A9AC-43A6-80F5-B68EFB7CB51C}" dt="2025-11-07T01:42:46.088" v="69" actId="20577"/>
          <ac:spMkLst>
            <pc:docMk/>
            <pc:sldMk cId="906878716" sldId="324"/>
            <ac:spMk id="2" creationId="{6C9EDF7B-37E2-DF5C-ADC6-4B3E2B58F667}"/>
          </ac:spMkLst>
        </pc:spChg>
        <pc:picChg chg="add mod">
          <ac:chgData name="亮太 松井" userId="b1607756e1acfed1" providerId="LiveId" clId="{0A77853B-A9AC-43A6-80F5-B68EFB7CB51C}" dt="2025-11-07T01:43:22.840" v="73" actId="1076"/>
          <ac:picMkLst>
            <pc:docMk/>
            <pc:sldMk cId="906878716" sldId="324"/>
            <ac:picMk id="4" creationId="{39BFAFFF-799D-A1BC-22B0-AD986AFDD18D}"/>
          </ac:picMkLst>
        </pc:picChg>
      </pc:sldChg>
      <pc:sldChg chg="addSp modSp new mod modNotesTx">
        <pc:chgData name="亮太 松井" userId="b1607756e1acfed1" providerId="LiveId" clId="{0A77853B-A9AC-43A6-80F5-B68EFB7CB51C}" dt="2025-11-07T01:45:10.938" v="176" actId="20577"/>
        <pc:sldMkLst>
          <pc:docMk/>
          <pc:sldMk cId="2323716768" sldId="325"/>
        </pc:sldMkLst>
        <pc:spChg chg="add mod">
          <ac:chgData name="亮太 松井" userId="b1607756e1acfed1" providerId="LiveId" clId="{0A77853B-A9AC-43A6-80F5-B68EFB7CB51C}" dt="2025-11-07T01:44:23.138" v="128" actId="20577"/>
          <ac:spMkLst>
            <pc:docMk/>
            <pc:sldMk cId="2323716768" sldId="325"/>
            <ac:spMk id="2" creationId="{888F17CD-EF3E-B1AB-3D83-B663A31B9AF6}"/>
          </ac:spMkLst>
        </pc:spChg>
        <pc:picChg chg="add mod">
          <ac:chgData name="亮太 松井" userId="b1607756e1acfed1" providerId="LiveId" clId="{0A77853B-A9AC-43A6-80F5-B68EFB7CB51C}" dt="2025-11-07T01:44:50.890" v="131" actId="14100"/>
          <ac:picMkLst>
            <pc:docMk/>
            <pc:sldMk cId="2323716768" sldId="325"/>
            <ac:picMk id="4" creationId="{CC1A881E-8B7B-689B-2E25-3ABAA3A93060}"/>
          </ac:picMkLst>
        </pc:picChg>
      </pc:sldChg>
      <pc:sldChg chg="addSp modSp new mod modNotesTx">
        <pc:chgData name="亮太 松井" userId="b1607756e1acfed1" providerId="LiveId" clId="{0A77853B-A9AC-43A6-80F5-B68EFB7CB51C}" dt="2025-11-07T01:46:25.529" v="227" actId="20577"/>
        <pc:sldMkLst>
          <pc:docMk/>
          <pc:sldMk cId="211528446" sldId="326"/>
        </pc:sldMkLst>
        <pc:spChg chg="add mod">
          <ac:chgData name="亮太 松井" userId="b1607756e1acfed1" providerId="LiveId" clId="{0A77853B-A9AC-43A6-80F5-B68EFB7CB51C}" dt="2025-11-07T01:45:46.188" v="180" actId="20577"/>
          <ac:spMkLst>
            <pc:docMk/>
            <pc:sldMk cId="211528446" sldId="326"/>
            <ac:spMk id="2" creationId="{BE9D4BCA-A51D-F4C0-9743-B093765D3AD6}"/>
          </ac:spMkLst>
        </pc:spChg>
        <pc:picChg chg="add mod">
          <ac:chgData name="亮太 松井" userId="b1607756e1acfed1" providerId="LiveId" clId="{0A77853B-A9AC-43A6-80F5-B68EFB7CB51C}" dt="2025-11-07T01:46:12.344" v="183" actId="14100"/>
          <ac:picMkLst>
            <pc:docMk/>
            <pc:sldMk cId="211528446" sldId="326"/>
            <ac:picMk id="4" creationId="{C69E01AB-C9BF-95FE-719C-267473543231}"/>
          </ac:picMkLst>
        </pc:picChg>
      </pc:sldChg>
      <pc:sldChg chg="addSp modSp new mod modNotesTx">
        <pc:chgData name="亮太 松井" userId="b1607756e1acfed1" providerId="LiveId" clId="{0A77853B-A9AC-43A6-80F5-B68EFB7CB51C}" dt="2025-11-07T01:47:41.549" v="267" actId="20577"/>
        <pc:sldMkLst>
          <pc:docMk/>
          <pc:sldMk cId="2293565748" sldId="327"/>
        </pc:sldMkLst>
        <pc:spChg chg="add mod">
          <ac:chgData name="亮太 松井" userId="b1607756e1acfed1" providerId="LiveId" clId="{0A77853B-A9AC-43A6-80F5-B68EFB7CB51C}" dt="2025-11-07T01:46:56.950" v="231" actId="20577"/>
          <ac:spMkLst>
            <pc:docMk/>
            <pc:sldMk cId="2293565748" sldId="327"/>
            <ac:spMk id="2" creationId="{3201BCFE-BEE0-1F62-EBE8-096E9406B3ED}"/>
          </ac:spMkLst>
        </pc:spChg>
        <pc:picChg chg="add mod">
          <ac:chgData name="亮太 松井" userId="b1607756e1acfed1" providerId="LiveId" clId="{0A77853B-A9AC-43A6-80F5-B68EFB7CB51C}" dt="2025-11-07T01:47:27.595" v="234" actId="14100"/>
          <ac:picMkLst>
            <pc:docMk/>
            <pc:sldMk cId="2293565748" sldId="327"/>
            <ac:picMk id="4" creationId="{33CA0C9D-B889-E9F7-3F81-1F728A1D3872}"/>
          </ac:picMkLst>
        </pc:picChg>
      </pc:sldChg>
      <pc:sldChg chg="addSp modSp new mod modNotesTx">
        <pc:chgData name="亮太 松井" userId="b1607756e1acfed1" providerId="LiveId" clId="{0A77853B-A9AC-43A6-80F5-B68EFB7CB51C}" dt="2025-11-07T01:49:17.221" v="306" actId="20577"/>
        <pc:sldMkLst>
          <pc:docMk/>
          <pc:sldMk cId="2664767405" sldId="328"/>
        </pc:sldMkLst>
        <pc:spChg chg="add mod">
          <ac:chgData name="亮太 松井" userId="b1607756e1acfed1" providerId="LiveId" clId="{0A77853B-A9AC-43A6-80F5-B68EFB7CB51C}" dt="2025-11-07T01:48:14.481" v="271" actId="20577"/>
          <ac:spMkLst>
            <pc:docMk/>
            <pc:sldMk cId="2664767405" sldId="328"/>
            <ac:spMk id="2" creationId="{98E848E2-F32C-53B9-59BA-8CD657A4429D}"/>
          </ac:spMkLst>
        </pc:spChg>
        <pc:picChg chg="add mod">
          <ac:chgData name="亮太 松井" userId="b1607756e1acfed1" providerId="LiveId" clId="{0A77853B-A9AC-43A6-80F5-B68EFB7CB51C}" dt="2025-11-07T01:49:02.368" v="274" actId="14100"/>
          <ac:picMkLst>
            <pc:docMk/>
            <pc:sldMk cId="2664767405" sldId="328"/>
            <ac:picMk id="4" creationId="{5D66450F-0586-AEE3-25A2-D0C108C5CBFC}"/>
          </ac:picMkLst>
        </pc:picChg>
      </pc:sldChg>
      <pc:sldChg chg="addSp modSp new mod modNotesTx">
        <pc:chgData name="亮太 松井" userId="b1607756e1acfed1" providerId="LiveId" clId="{0A77853B-A9AC-43A6-80F5-B68EFB7CB51C}" dt="2025-11-07T01:50:53.245" v="377" actId="20577"/>
        <pc:sldMkLst>
          <pc:docMk/>
          <pc:sldMk cId="3628792867" sldId="329"/>
        </pc:sldMkLst>
        <pc:spChg chg="add mod">
          <ac:chgData name="亮太 松井" userId="b1607756e1acfed1" providerId="LiveId" clId="{0A77853B-A9AC-43A6-80F5-B68EFB7CB51C}" dt="2025-11-07T01:49:50.203" v="312" actId="20577"/>
          <ac:spMkLst>
            <pc:docMk/>
            <pc:sldMk cId="3628792867" sldId="329"/>
            <ac:spMk id="2" creationId="{F848A0F4-88CC-48BF-5528-1235012E2666}"/>
          </ac:spMkLst>
        </pc:spChg>
        <pc:picChg chg="add mod">
          <ac:chgData name="亮太 松井" userId="b1607756e1acfed1" providerId="LiveId" clId="{0A77853B-A9AC-43A6-80F5-B68EFB7CB51C}" dt="2025-11-07T01:50:36.120" v="328" actId="1037"/>
          <ac:picMkLst>
            <pc:docMk/>
            <pc:sldMk cId="3628792867" sldId="329"/>
            <ac:picMk id="4" creationId="{78C29EF0-CAAC-0334-2850-FDE7C1472E18}"/>
          </ac:picMkLst>
        </pc:picChg>
      </pc:sldChg>
      <pc:sldChg chg="addSp modSp new mod modNotesTx">
        <pc:chgData name="亮太 松井" userId="b1607756e1acfed1" providerId="LiveId" clId="{0A77853B-A9AC-43A6-80F5-B68EFB7CB51C}" dt="2025-11-07T01:52:14.897" v="442" actId="14100"/>
        <pc:sldMkLst>
          <pc:docMk/>
          <pc:sldMk cId="751095263" sldId="330"/>
        </pc:sldMkLst>
        <pc:spChg chg="add mod">
          <ac:chgData name="亮太 松井" userId="b1607756e1acfed1" providerId="LiveId" clId="{0A77853B-A9AC-43A6-80F5-B68EFB7CB51C}" dt="2025-11-07T01:51:22.779" v="381" actId="20577"/>
          <ac:spMkLst>
            <pc:docMk/>
            <pc:sldMk cId="751095263" sldId="330"/>
            <ac:spMk id="2" creationId="{55ECB517-9810-1B30-8181-E6D699444AA8}"/>
          </ac:spMkLst>
        </pc:spChg>
        <pc:picChg chg="add mod">
          <ac:chgData name="亮太 松井" userId="b1607756e1acfed1" providerId="LiveId" clId="{0A77853B-A9AC-43A6-80F5-B68EFB7CB51C}" dt="2025-11-07T01:52:14.897" v="442" actId="14100"/>
          <ac:picMkLst>
            <pc:docMk/>
            <pc:sldMk cId="751095263" sldId="330"/>
            <ac:picMk id="4" creationId="{4CC6C2FD-B8DF-A1F2-00F8-B0D75CDC4309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7C1FEA-D5D1-45BB-AB4D-2D73ECD2B380}" type="datetimeFigureOut">
              <a:rPr kumimoji="1" lang="ja-JP" altLang="en-US" smtClean="0"/>
              <a:t>2025/11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4E21E4-63FB-4AED-8EBC-148A790CAB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5756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3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2.xml"/><Relationship Id="rId1" Type="http://schemas.openxmlformats.org/officeDocument/2006/relationships/notesMaster" Target="../notesMasters/notesMaster1.xml"/></Relationships>
</file>

<file path=ppt/notesSlides/_rels/notesSlide3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3.xml"/><Relationship Id="rId1" Type="http://schemas.openxmlformats.org/officeDocument/2006/relationships/notesMaster" Target="../notesMasters/notesMaster1.xml"/></Relationships>
</file>

<file path=ppt/notesSlides/_rels/notesSlide3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4.xml"/><Relationship Id="rId1" Type="http://schemas.openxmlformats.org/officeDocument/2006/relationships/notesMaster" Target="../notesMasters/notesMaster1.xml"/></Relationships>
</file>

<file path=ppt/notesSlides/_rels/notesSlide3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5.xml"/><Relationship Id="rId1" Type="http://schemas.openxmlformats.org/officeDocument/2006/relationships/notesMaster" Target="../notesMasters/notesMaster1.xml"/></Relationships>
</file>

<file path=ppt/notesSlides/_rels/notesSlide3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3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7.xml"/><Relationship Id="rId1" Type="http://schemas.openxmlformats.org/officeDocument/2006/relationships/notesMaster" Target="../notesMasters/notesMaster1.xml"/></Relationships>
</file>

<file path=ppt/notesSlides/_rels/notesSlide3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8.xml"/><Relationship Id="rId1" Type="http://schemas.openxmlformats.org/officeDocument/2006/relationships/notesMaster" Target="../notesMasters/notesMaster1.xml"/></Relationships>
</file>

<file path=ppt/notesSlides/_rels/notesSlide3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0.xml"/><Relationship Id="rId1" Type="http://schemas.openxmlformats.org/officeDocument/2006/relationships/notesMaster" Target="../notesMasters/notesMaster1.xml"/></Relationships>
</file>

<file path=ppt/notesSlides/_rels/notesSlide4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1.xml"/><Relationship Id="rId1" Type="http://schemas.openxmlformats.org/officeDocument/2006/relationships/notesMaster" Target="../notesMasters/notesMaster1.xml"/></Relationships>
</file>

<file path=ppt/notesSlides/_rels/notesSlide4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2.xml"/><Relationship Id="rId1" Type="http://schemas.openxmlformats.org/officeDocument/2006/relationships/notesMaster" Target="../notesMasters/notesMaster1.xml"/></Relationships>
</file>

<file path=ppt/notesSlides/_rels/notesSlide4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3.xml"/><Relationship Id="rId1" Type="http://schemas.openxmlformats.org/officeDocument/2006/relationships/notesMaster" Target="../notesMasters/notesMaster1.xml"/></Relationships>
</file>

<file path=ppt/notesSlides/_rels/notesSlide4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4.xml"/><Relationship Id="rId1" Type="http://schemas.openxmlformats.org/officeDocument/2006/relationships/notesMaster" Target="../notesMasters/notesMaster1.xml"/></Relationships>
</file>

<file path=ppt/notesSlides/_rels/notesSlide4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5.xml"/><Relationship Id="rId1" Type="http://schemas.openxmlformats.org/officeDocument/2006/relationships/notesMaster" Target="../notesMasters/notesMaster1.xml"/></Relationships>
</file>

<file path=ppt/notesSlides/_rels/notesSlide4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6.xml"/><Relationship Id="rId1" Type="http://schemas.openxmlformats.org/officeDocument/2006/relationships/notesMaster" Target="../notesMasters/notesMaster1.xml"/></Relationships>
</file>

<file path=ppt/notesSlides/_rels/notesSlide4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7.xml"/><Relationship Id="rId1" Type="http://schemas.openxmlformats.org/officeDocument/2006/relationships/notesMaster" Target="../notesMasters/notesMaster1.xml"/></Relationships>
</file>

<file path=ppt/notesSlides/_rels/notesSlide4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8.xml"/><Relationship Id="rId1" Type="http://schemas.openxmlformats.org/officeDocument/2006/relationships/notesMaster" Target="../notesMasters/notesMaster1.xml"/></Relationships>
</file>

<file path=ppt/notesSlides/_rels/notesSlide4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9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0.xml"/><Relationship Id="rId1" Type="http://schemas.openxmlformats.org/officeDocument/2006/relationships/notesMaster" Target="../notesMasters/notesMaster1.xml"/></Relationships>
</file>

<file path=ppt/notesSlides/_rels/notesSlide5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1.xml"/><Relationship Id="rId1" Type="http://schemas.openxmlformats.org/officeDocument/2006/relationships/notesMaster" Target="../notesMasters/notesMaster1.xml"/></Relationships>
</file>

<file path=ppt/notesSlides/_rels/notesSlide5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2.xml"/><Relationship Id="rId1" Type="http://schemas.openxmlformats.org/officeDocument/2006/relationships/notesMaster" Target="../notesMasters/notesMaster1.xml"/></Relationships>
</file>

<file path=ppt/notesSlides/_rels/notesSlide5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3.xml"/><Relationship Id="rId1" Type="http://schemas.openxmlformats.org/officeDocument/2006/relationships/notesMaster" Target="../notesMasters/notesMaster1.xml"/></Relationships>
</file>

<file path=ppt/notesSlides/_rels/notesSlide5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4.xml"/><Relationship Id="rId1" Type="http://schemas.openxmlformats.org/officeDocument/2006/relationships/notesMaster" Target="../notesMasters/notesMaster1.xml"/></Relationships>
</file>

<file path=ppt/notesSlides/_rels/notesSlide5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0135740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RFS</a:t>
            </a:r>
            <a:r>
              <a:rPr kumimoji="1" lang="ja-JP" altLang="en-US" dirty="0"/>
              <a:t>：感度分析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10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6345340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total postoperative complications </a:t>
            </a:r>
            <a:r>
              <a:rPr lang="ja-JP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 </a:t>
            </a:r>
            <a:r>
              <a:rPr lang="en-US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severity of malnutrition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1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753770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total postoperative complications in cancer types (gastric or esophageal cancer)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1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5033655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total postoperative complications</a:t>
            </a:r>
            <a:r>
              <a:rPr lang="ja-JP" altLang="en-US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1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7625639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total postoperative complications</a:t>
            </a:r>
            <a:r>
              <a:rPr lang="ja-JP" altLang="en-US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ja-JP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method of assessed skeletal muscle mass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1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9702889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total postoperative complications</a:t>
            </a:r>
            <a:r>
              <a:rPr lang="ja-JP" altLang="en-US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ja-JP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</a:t>
            </a:r>
            <a:r>
              <a:rPr lang="en-US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rgical approach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1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8911522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/>
              <a:t>術後合併症総数：感度分析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1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908964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severe complications</a:t>
            </a:r>
            <a:r>
              <a:rPr lang="ja-JP" altLang="en-US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ja-JP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</a:t>
            </a:r>
            <a:r>
              <a:rPr lang="en-US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rgical approach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1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379476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severe complications in cancer types (gastric or esophageal cancer)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1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2457240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severe complications </a:t>
            </a:r>
            <a:r>
              <a:rPr lang="ja-JP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 </a:t>
            </a:r>
            <a:r>
              <a:rPr lang="en-US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severity of malnutrition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1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869025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ja-JP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Forest plot of overall survival according to </a:t>
            </a:r>
            <a:r>
              <a:rPr lang="en-US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severity of malnutrition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343441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severe complications in cancer types (GI or HPB)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20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3194808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severe complications</a:t>
            </a:r>
            <a:r>
              <a:rPr lang="ja-JP" altLang="en-US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2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1504583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severe complications</a:t>
            </a:r>
            <a:r>
              <a:rPr lang="ja-JP" altLang="en-US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ja-JP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</a:t>
            </a:r>
            <a:r>
              <a:rPr lang="en-US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method of assessed skeletal muscle mass</a:t>
            </a:r>
            <a:endParaRPr kumimoji="1" lang="ja-JP" altLang="en-US" dirty="0"/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2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9369419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/>
              <a:t>重症合併症：感度分析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2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7746548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</a:t>
            </a:r>
            <a:r>
              <a:rPr kumimoji="1"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</a:t>
            </a:r>
            <a:r>
              <a:rPr kumimoji="1" lang="en-US" altLang="ja-JP" dirty="0"/>
              <a:t>nfectious </a:t>
            </a: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omplications </a:t>
            </a:r>
            <a:r>
              <a:rPr lang="ja-JP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 </a:t>
            </a:r>
            <a:r>
              <a:rPr lang="en-US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severity of malnutrition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2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6682622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</a:t>
            </a:r>
            <a:r>
              <a:rPr kumimoji="1"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</a:t>
            </a:r>
            <a:r>
              <a:rPr kumimoji="1" lang="en-US" altLang="ja-JP" dirty="0"/>
              <a:t>nfectious </a:t>
            </a: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omplications in cancer types (gastric or esophageal cancer)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2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0038237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</a:t>
            </a:r>
            <a:r>
              <a:rPr kumimoji="1"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</a:t>
            </a:r>
            <a:r>
              <a:rPr kumimoji="1" lang="en-US" altLang="ja-JP" dirty="0"/>
              <a:t>nfectious </a:t>
            </a: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omplications </a:t>
            </a:r>
            <a:r>
              <a:rPr lang="ja-JP" altLang="ja-JP" sz="10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</a:t>
            </a:r>
            <a:r>
              <a:rPr lang="en-US" altLang="ja-JP" sz="10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rgical approach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2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5807624"/>
      </p:ext>
    </p:extLst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</a:t>
            </a:r>
            <a:r>
              <a:rPr kumimoji="1"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</a:t>
            </a:r>
            <a:r>
              <a:rPr kumimoji="1" lang="en-US" altLang="ja-JP" dirty="0"/>
              <a:t>nfectious </a:t>
            </a: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omplications 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2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9231557"/>
      </p:ext>
    </p:extLst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/>
              <a:t>感染性合併症：感度分析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2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008280"/>
      </p:ext>
    </p:extLst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</a:t>
            </a:r>
            <a:r>
              <a:rPr kumimoji="1"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kumimoji="1" lang="en-US" altLang="ja-JP" dirty="0"/>
              <a:t>nastomotic leakage</a:t>
            </a: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ja-JP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 </a:t>
            </a:r>
            <a:r>
              <a:rPr lang="en-US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severity of malnutrition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2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964886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overall survival in cancer types (gastric or esophageal cancer)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5708958"/>
      </p:ext>
    </p:extLst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</a:t>
            </a:r>
            <a:r>
              <a:rPr kumimoji="1"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kumimoji="1" lang="en-US" altLang="ja-JP" dirty="0"/>
              <a:t>nastomotic leakage </a:t>
            </a: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cancer types (gastric or esophageal cancer)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30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0640619"/>
      </p:ext>
    </p:extLst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</a:t>
            </a:r>
            <a:r>
              <a:rPr kumimoji="1"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kumimoji="1" lang="en-US" altLang="ja-JP" dirty="0"/>
              <a:t>nastomotic leakage </a:t>
            </a:r>
            <a:r>
              <a:rPr lang="ja-JP" altLang="ja-JP" sz="10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</a:t>
            </a:r>
            <a:r>
              <a:rPr lang="en-US" altLang="ja-JP" sz="10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rgical approach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3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8123176"/>
      </p:ext>
    </p:extLst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</a:t>
            </a:r>
            <a:r>
              <a:rPr kumimoji="1"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kumimoji="1" lang="en-US" altLang="ja-JP" dirty="0"/>
              <a:t>nastomotic leakage 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3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6068428"/>
      </p:ext>
    </p:extLst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/>
              <a:t>縫合不全：感度分析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3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6156048"/>
      </p:ext>
    </p:extLst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postoperative p</a:t>
            </a:r>
            <a:r>
              <a:rPr kumimoji="1" lang="en-US" altLang="ja-JP" dirty="0"/>
              <a:t>neumonia </a:t>
            </a:r>
            <a:r>
              <a:rPr lang="ja-JP" altLang="ja-JP" sz="10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 </a:t>
            </a:r>
            <a:r>
              <a:rPr lang="en-US" altLang="ja-JP" sz="10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severity of malnutrition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3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4549338"/>
      </p:ext>
    </p:extLst>
  </p:cSld>
  <p:clrMapOvr>
    <a:masterClrMapping/>
  </p:clrMapOvr>
</p:notes>
</file>

<file path=ppt/notesSlides/notesSlide3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postoperative p</a:t>
            </a:r>
            <a:r>
              <a:rPr kumimoji="1" lang="en-US" altLang="ja-JP" dirty="0"/>
              <a:t>neumonia </a:t>
            </a: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cancer types (gastric or esophageal cancer)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3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2035153"/>
      </p:ext>
    </p:extLst>
  </p:cSld>
  <p:clrMapOvr>
    <a:masterClrMapping/>
  </p:clrMapOvr>
</p:notes>
</file>

<file path=ppt/notesSlides/notesSlide3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postoperative p</a:t>
            </a:r>
            <a:r>
              <a:rPr kumimoji="1" lang="en-US" altLang="ja-JP" dirty="0"/>
              <a:t>neumonia </a:t>
            </a:r>
            <a:r>
              <a:rPr lang="ja-JP" altLang="ja-JP" sz="10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</a:t>
            </a:r>
            <a:r>
              <a:rPr lang="en-US" altLang="ja-JP" sz="10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rgical approach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3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5410847"/>
      </p:ext>
    </p:extLst>
  </p:cSld>
  <p:clrMapOvr>
    <a:masterClrMapping/>
  </p:clrMapOvr>
</p:notes>
</file>

<file path=ppt/notesSlides/notesSlide3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postoperative p</a:t>
            </a:r>
            <a:r>
              <a:rPr kumimoji="1" lang="en-US" altLang="ja-JP" dirty="0"/>
              <a:t>neumonia 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3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9106544"/>
      </p:ext>
    </p:extLst>
  </p:cSld>
  <p:clrMapOvr>
    <a:masterClrMapping/>
  </p:clrMapOvr>
</p:notes>
</file>

<file path=ppt/notesSlides/notesSlide3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/>
              <a:t>肺炎：感度分析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3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4334786"/>
      </p:ext>
    </p:extLst>
  </p:cSld>
  <p:clrMapOvr>
    <a:masterClrMapping/>
  </p:clrMapOvr>
</p:notes>
</file>

<file path=ppt/notesSlides/notesSlide3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</a:t>
            </a:r>
            <a:r>
              <a:rPr kumimoji="1"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</a:t>
            </a:r>
            <a:r>
              <a:rPr kumimoji="1" lang="en-US" altLang="ja-JP" dirty="0"/>
              <a:t>ortality</a:t>
            </a:r>
            <a:r>
              <a:rPr kumimoji="1" lang="ja-JP" altLang="en-US" dirty="0"/>
              <a:t> </a:t>
            </a: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cancer types (gastric or esophageal cancer)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3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447280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overall survival in cancer types (GI or HPB)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6506646"/>
      </p:ext>
    </p:extLst>
  </p:cSld>
  <p:clrMapOvr>
    <a:masterClrMapping/>
  </p:clrMapOvr>
</p:notes>
</file>

<file path=ppt/notesSlides/notesSlide4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</a:t>
            </a:r>
            <a:r>
              <a:rPr kumimoji="1" lang="en-US" altLang="ja-JP" sz="10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</a:t>
            </a:r>
            <a:r>
              <a:rPr kumimoji="1" lang="en-US" altLang="ja-JP" dirty="0"/>
              <a:t>ortality</a:t>
            </a:r>
            <a:r>
              <a:rPr kumimoji="1" lang="ja-JP" altLang="en-US" dirty="0"/>
              <a:t> </a:t>
            </a:r>
            <a:r>
              <a:rPr lang="ja-JP" altLang="ja-JP" sz="8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</a:t>
            </a:r>
            <a:r>
              <a:rPr lang="en-US" altLang="ja-JP" sz="8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rgical approach</a:t>
            </a:r>
            <a:endParaRPr lang="ja-JP" altLang="ja-JP" sz="10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40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6770645"/>
      </p:ext>
    </p:extLst>
  </p:cSld>
  <p:clrMapOvr>
    <a:masterClrMapping/>
  </p:clrMapOvr>
</p:notes>
</file>

<file path=ppt/notesSlides/notesSlide4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</a:t>
            </a:r>
            <a:r>
              <a:rPr kumimoji="1"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</a:t>
            </a:r>
            <a:r>
              <a:rPr kumimoji="1" lang="en-US" altLang="ja-JP" dirty="0"/>
              <a:t>ortality</a:t>
            </a:r>
            <a:r>
              <a:rPr kumimoji="1" lang="ja-JP" altLang="en-US" dirty="0"/>
              <a:t> </a:t>
            </a:r>
            <a:r>
              <a:rPr lang="ja-JP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method of assessed skeletal muscle mass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4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8429876"/>
      </p:ext>
    </p:extLst>
  </p:cSld>
  <p:clrMapOvr>
    <a:masterClrMapping/>
  </p:clrMapOvr>
</p:notes>
</file>

<file path=ppt/notesSlides/notesSlide4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/>
              <a:t>術後死亡：感度分析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4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196924"/>
      </p:ext>
    </p:extLst>
  </p:cSld>
  <p:clrMapOvr>
    <a:masterClrMapping/>
  </p:clrMapOvr>
</p:notes>
</file>

<file path=ppt/notesSlides/notesSlide4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ostoperative hospital stay</a:t>
            </a:r>
            <a:r>
              <a:rPr kumimoji="1" lang="en-US" altLang="ja-JP" dirty="0"/>
              <a:t> </a:t>
            </a:r>
            <a:r>
              <a:rPr lang="ja-JP" altLang="ja-JP" sz="10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 </a:t>
            </a:r>
            <a:r>
              <a:rPr lang="en-US" altLang="ja-JP" sz="10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severity of malnutrition</a:t>
            </a:r>
            <a:endParaRPr kumimoji="1" lang="ja-JP" alt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4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0957905"/>
      </p:ext>
    </p:extLst>
  </p:cSld>
  <p:clrMapOvr>
    <a:masterClrMapping/>
  </p:clrMapOvr>
</p:notes>
</file>

<file path=ppt/notesSlides/notesSlide4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0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ostoperative hospital stay </a:t>
            </a: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cancer types (gastric or esophageal cancer)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4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2354428"/>
      </p:ext>
    </p:extLst>
  </p:cSld>
  <p:clrMapOvr>
    <a:masterClrMapping/>
  </p:clrMapOvr>
</p:notes>
</file>

<file path=ppt/notesSlides/notesSlide4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0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ostoperative hospital stay </a:t>
            </a: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cancer types (GI or HPB)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4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0000789"/>
      </p:ext>
    </p:extLst>
  </p:cSld>
  <p:clrMapOvr>
    <a:masterClrMapping/>
  </p:clrMapOvr>
</p:notes>
</file>

<file path=ppt/notesSlides/notesSlide4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0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ostoperative hospital stay </a:t>
            </a:r>
            <a:r>
              <a:rPr lang="ja-JP" altLang="ja-JP" sz="10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</a:t>
            </a:r>
            <a:r>
              <a:rPr lang="en-US" altLang="ja-JP" sz="10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rgical approach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4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6243944"/>
      </p:ext>
    </p:extLst>
  </p:cSld>
  <p:clrMapOvr>
    <a:masterClrMapping/>
  </p:clrMapOvr>
</p:notes>
</file>

<file path=ppt/notesSlides/notesSlide4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0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ostoperative hospital stay </a:t>
            </a:r>
            <a:r>
              <a:rPr lang="ja-JP" altLang="ja-JP" sz="10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method of assessed skeletal muscle mass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96BB82-5A06-4D85-840D-FCFC3B2F4348}" type="slidenum">
              <a:rPr kumimoji="1" lang="ja-JP" altLang="en-US" smtClean="0"/>
              <a:t>4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1473893"/>
      </p:ext>
    </p:extLst>
  </p:cSld>
  <p:clrMapOvr>
    <a:masterClrMapping/>
  </p:clrMapOvr>
</p:notes>
</file>

<file path=ppt/notesSlides/notesSlide4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/>
              <a:t>術後在院日数：感度分析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4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4903476"/>
      </p:ext>
    </p:extLst>
  </p:cSld>
  <p:clrMapOvr>
    <a:masterClrMapping/>
  </p:clrMapOvr>
</p:notes>
</file>

<file path=ppt/notesSlides/notesSlide4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ja-JP" altLang="ja-JP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Funnel plots of </a:t>
            </a:r>
            <a:r>
              <a:rPr lang="ja-JP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overall survival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4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400010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overall survival</a:t>
            </a:r>
            <a:r>
              <a:rPr lang="ja-JP" altLang="en-US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9589626"/>
      </p:ext>
    </p:extLst>
  </p:cSld>
  <p:clrMapOvr>
    <a:masterClrMapping/>
  </p:clrMapOvr>
</p:notes>
</file>

<file path=ppt/notesSlides/notesSlide5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ja-JP" altLang="ja-JP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Funnel plots of</a:t>
            </a:r>
            <a:r>
              <a:rPr lang="en-US" altLang="ja-JP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total postoperative complications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50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1297838"/>
      </p:ext>
    </p:extLst>
  </p:cSld>
  <p:clrMapOvr>
    <a:masterClrMapping/>
  </p:clrMapOvr>
</p:notes>
</file>

<file path=ppt/notesSlides/notesSlide5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ja-JP" altLang="ja-JP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Funnel plots of</a:t>
            </a:r>
            <a:r>
              <a:rPr lang="en-US" altLang="ja-JP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severe complications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5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9164749"/>
      </p:ext>
    </p:extLst>
  </p:cSld>
  <p:clrMapOvr>
    <a:masterClrMapping/>
  </p:clrMapOvr>
</p:notes>
</file>

<file path=ppt/notesSlides/notesSlide5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ja-JP" altLang="ja-JP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Funnel plots of</a:t>
            </a:r>
            <a:r>
              <a:rPr lang="en-US" altLang="ja-JP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infectious complications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5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602413"/>
      </p:ext>
    </p:extLst>
  </p:cSld>
  <p:clrMapOvr>
    <a:masterClrMapping/>
  </p:clrMapOvr>
</p:notes>
</file>

<file path=ppt/notesSlides/notesSlide5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ja-JP" altLang="ja-JP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Funnel plots of</a:t>
            </a:r>
            <a:r>
              <a:rPr lang="en-US" altLang="ja-JP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</a:t>
            </a:r>
            <a:r>
              <a:rPr kumimoji="1" lang="en-US" altLang="ja-JP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a</a:t>
            </a:r>
            <a:r>
              <a:rPr kumimoji="1" lang="en-US" altLang="ja-JP" dirty="0"/>
              <a:t>nastomotic leakage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5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3838083"/>
      </p:ext>
    </p:extLst>
  </p:cSld>
  <p:clrMapOvr>
    <a:masterClrMapping/>
  </p:clrMapOvr>
</p:notes>
</file>

<file path=ppt/notesSlides/notesSlide5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ja-JP" altLang="ja-JP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Funnel plots of</a:t>
            </a:r>
            <a:r>
              <a:rPr lang="en-US" altLang="ja-JP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</a:t>
            </a:r>
            <a:r>
              <a:rPr kumimoji="1" lang="en-US" altLang="ja-JP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pneumonia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5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8812689"/>
      </p:ext>
    </p:extLst>
  </p:cSld>
  <p:clrMapOvr>
    <a:masterClrMapping/>
  </p:clrMapOvr>
</p:notes>
</file>

<file path=ppt/notesSlides/notesSlide5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ja-JP" altLang="ja-JP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Funnel plots of</a:t>
            </a:r>
            <a:r>
              <a:rPr lang="en-US" altLang="ja-JP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postoperative hospital stay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5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453103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overall survival</a:t>
            </a:r>
            <a:r>
              <a:rPr lang="ja-JP" altLang="en-US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ja-JP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method of assessed skeletal muscle mass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950392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overall survival</a:t>
            </a:r>
            <a:r>
              <a:rPr lang="ja-JP" altLang="en-US" sz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ja-JP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</a:t>
            </a:r>
            <a:r>
              <a:rPr lang="en-US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rgical approach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811376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OS</a:t>
            </a:r>
            <a:r>
              <a:rPr kumimoji="1" lang="ja-JP" altLang="en-US" dirty="0"/>
              <a:t>：感度分析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75185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RFS </a:t>
            </a:r>
            <a:r>
              <a:rPr lang="ja-JP" altLang="ja-JP" sz="18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ccording to </a:t>
            </a:r>
            <a:r>
              <a:rPr lang="en-US" altLang="ja-JP" sz="18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severity of malnutrition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4E21E4-63FB-4AED-8EBC-148A790CAB4A}" type="slidenum">
              <a:rPr kumimoji="1" lang="ja-JP" altLang="en-US" smtClean="0"/>
              <a:t>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31941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AD07692-E0A7-4EBD-94BD-36C599FDD63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630632D-24AC-4CA4-8B5D-CE3D58B173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C24AA57-B1A1-4BBF-8F2D-172404FEF5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CC9C-2E2A-4CC7-B1EC-430968A4984A}" type="datetimeFigureOut">
              <a:rPr kumimoji="1" lang="ja-JP" altLang="en-US" smtClean="0"/>
              <a:t>2025/11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AC9E3BB-5E9D-4802-BB71-018BEEE175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32F9956-CC7C-4DB7-BF36-5EBA865C06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BC5E2-1A2A-4B52-8D00-AC1B59C763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9343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B304EC-BA30-4486-89AA-A5979E2E65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43F341C-8A74-450F-B324-DEE0DD5BE4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99665BE-C88D-41CC-9766-51DA2BC6F1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CC9C-2E2A-4CC7-B1EC-430968A4984A}" type="datetimeFigureOut">
              <a:rPr kumimoji="1" lang="ja-JP" altLang="en-US" smtClean="0"/>
              <a:t>2025/11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2734B6D-2AFD-4091-ADF2-E9E2F8D5E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E126303-9D3D-494F-BC51-FADE01575F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BC5E2-1A2A-4B52-8D00-AC1B59C763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40986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D38CC84-4B26-40E7-98A0-5E39E3DA081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6B18315-FD5F-4F4D-9ED9-48AFAE0014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71DEA32-114E-4B1F-8501-C6EF7A7356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CC9C-2E2A-4CC7-B1EC-430968A4984A}" type="datetimeFigureOut">
              <a:rPr kumimoji="1" lang="ja-JP" altLang="en-US" smtClean="0"/>
              <a:t>2025/11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6F78CF0-1E46-46E2-9CD4-C1E50CAD3D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1A6E7DA-6225-471D-A02D-6895369DE8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BC5E2-1A2A-4B52-8D00-AC1B59C763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789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1ED9E0B-64E2-47F4-9B8F-FFA9F7529F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C9056A-03F0-4AD0-B15C-21D01DD5988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01BA882-7DA4-4E8E-B3C4-FFF7374994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CC9C-2E2A-4CC7-B1EC-430968A4984A}" type="datetimeFigureOut">
              <a:rPr kumimoji="1" lang="ja-JP" altLang="en-US" smtClean="0"/>
              <a:t>2025/11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CAF67D0-4E3A-4B5F-B9A0-C9360CB05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291656C-BED4-4BE3-B522-1D3B98EBB9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BC5E2-1A2A-4B52-8D00-AC1B59C763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47191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52AA7E2-FD3B-4445-AD3A-B7237A0250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5345CAE-6823-4AE5-A27B-F49DAC3493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AD4D185-603F-4B35-86BC-DA1C14C536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CC9C-2E2A-4CC7-B1EC-430968A4984A}" type="datetimeFigureOut">
              <a:rPr kumimoji="1" lang="ja-JP" altLang="en-US" smtClean="0"/>
              <a:t>2025/11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139BAEC-C14D-4083-8CE7-6DE22CB27B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891DE46-D95B-48D5-8ACB-6AE0A2BD8C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BC5E2-1A2A-4B52-8D00-AC1B59C763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22650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0466F3-C0F0-4EA8-91D1-4ED99B667F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80D1FD1-4C31-4B3A-9ABD-02740689290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BC04F4C-2427-4F0F-A5EB-9C7389167C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A2BBA24-441E-44D4-B3F0-4A6637BA26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CC9C-2E2A-4CC7-B1EC-430968A4984A}" type="datetimeFigureOut">
              <a:rPr kumimoji="1" lang="ja-JP" altLang="en-US" smtClean="0"/>
              <a:t>2025/11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98AFEC6-1027-4AD8-8C14-A640FC414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3F23948-46EB-403E-90D7-9857035707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BC5E2-1A2A-4B52-8D00-AC1B59C763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4590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BBBEB7-81A1-4A49-A31F-B003DE4415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136FB50-DDC0-4516-91ED-F3BF2BEA3D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CF1C6BC-197D-480A-9FEE-EDC3DC0738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421C839-CBE5-4F5A-BF84-C6A34BF3A10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B65E666-A785-4C65-ADE6-1388D853C2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0258060-0514-483C-9512-2899233EC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CC9C-2E2A-4CC7-B1EC-430968A4984A}" type="datetimeFigureOut">
              <a:rPr kumimoji="1" lang="ja-JP" altLang="en-US" smtClean="0"/>
              <a:t>2025/11/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5381879-2F3D-4871-94FF-81CFFD6371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8DACC2A-B93D-4729-A23F-4E048F3031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BC5E2-1A2A-4B52-8D00-AC1B59C763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36334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92988F-261C-4BC9-AD50-EF6377247C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849F4D6-3BF0-435B-A660-6926C0BD4B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CC9C-2E2A-4CC7-B1EC-430968A4984A}" type="datetimeFigureOut">
              <a:rPr kumimoji="1" lang="ja-JP" altLang="en-US" smtClean="0"/>
              <a:t>2025/11/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D335B66-EEB9-43C1-9109-954B6D7114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BB8C848-0915-4AD7-9FD2-79EC204C36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BC5E2-1A2A-4B52-8D00-AC1B59C763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1506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7069104-E1D7-42B4-9F58-D9B08C3760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CC9C-2E2A-4CC7-B1EC-430968A4984A}" type="datetimeFigureOut">
              <a:rPr kumimoji="1" lang="ja-JP" altLang="en-US" smtClean="0"/>
              <a:t>2025/11/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201BAB6-D48B-44E6-B4B3-C4FA7EAE9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14F4391-9DB7-4F18-9804-9BA53CF4CE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BC5E2-1A2A-4B52-8D00-AC1B59C763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39177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2F98BCC-EBCF-4381-876D-18D3DEB9F7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F5D64C6-61EB-4798-8B59-EFDC2810552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8F35E47-A050-44D3-8EA9-71035DA484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6770D4D-B6E1-4ED0-86B3-5F4355A25B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CC9C-2E2A-4CC7-B1EC-430968A4984A}" type="datetimeFigureOut">
              <a:rPr kumimoji="1" lang="ja-JP" altLang="en-US" smtClean="0"/>
              <a:t>2025/11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0A30F49-3E82-4E75-8F41-C6BFE2654F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47FCB34-0A64-416F-AF9A-493FFF9455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BC5E2-1A2A-4B52-8D00-AC1B59C763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40310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E0BFD4F-2FA8-464C-90AE-BFB968371C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6BE5E0B-E27C-43CD-B11C-8EFE7F1F19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40FE074-31BA-4F64-B6BC-92487F9651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FCEA9BD-C110-4C72-88F8-6A68F93C5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4CC9C-2E2A-4CC7-B1EC-430968A4984A}" type="datetimeFigureOut">
              <a:rPr kumimoji="1" lang="ja-JP" altLang="en-US" smtClean="0"/>
              <a:t>2025/11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4504110-AFB6-4D1E-A8BA-8227742A94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6A97155-EBBA-4E48-B92D-FEE22A6FF7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BC5E2-1A2A-4B52-8D00-AC1B59C763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3659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244DEC0-D327-4DF8-AB81-1E13196858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2A94716-2A5B-4618-94FD-E6946171C3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E5546AB-7418-4F5E-A514-1BE1E0C060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C4CC9C-2E2A-4CC7-B1EC-430968A4984A}" type="datetimeFigureOut">
              <a:rPr kumimoji="1" lang="ja-JP" altLang="en-US" smtClean="0"/>
              <a:t>2025/11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2994006-0391-48CD-8177-5CE41EB5EF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4B61781-5805-429B-9BD1-62D6DB2E5D4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BBC5E2-1A2A-4B52-8D00-AC1B59C763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8327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notesSlide" Target="../notesSlides/notesSlide30.xml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notesSlide" Target="../notesSlides/notesSlide31.xml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32.xml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notesSlide" Target="../notesSlides/notesSlide33.xml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notesSlide" Target="../notesSlides/notesSlide34.xml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notesSlide" Target="../notesSlides/notesSlide35.xml"/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notesSlide" Target="../notesSlides/notesSlide36.xml"/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notesSlide" Target="../notesSlides/notesSlide37.xml"/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notesSlide" Target="../notesSlides/notesSlide38.xml"/><Relationship Id="rId1" Type="http://schemas.openxmlformats.org/officeDocument/2006/relationships/slideLayout" Target="../slideLayouts/slideLayout7.xm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notesSlide" Target="../notesSlides/notesSlide39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notesSlide" Target="../notesSlides/notesSlide40.xml"/><Relationship Id="rId1" Type="http://schemas.openxmlformats.org/officeDocument/2006/relationships/slideLayout" Target="../slideLayouts/slideLayout7.xml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notesSlide" Target="../notesSlides/notesSlide41.xml"/><Relationship Id="rId1" Type="http://schemas.openxmlformats.org/officeDocument/2006/relationships/slideLayout" Target="../slideLayouts/slideLayout7.xml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notesSlide" Target="../notesSlides/notesSlide42.xml"/><Relationship Id="rId1" Type="http://schemas.openxmlformats.org/officeDocument/2006/relationships/slideLayout" Target="../slideLayouts/slideLayout7.xml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notesSlide" Target="../notesSlides/notesSlide43.xml"/><Relationship Id="rId1" Type="http://schemas.openxmlformats.org/officeDocument/2006/relationships/slideLayout" Target="../slideLayouts/slideLayout7.xml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notesSlide" Target="../notesSlides/notesSlide44.xml"/><Relationship Id="rId1" Type="http://schemas.openxmlformats.org/officeDocument/2006/relationships/slideLayout" Target="../slideLayouts/slideLayout7.xml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notesSlide" Target="../notesSlides/notesSlide45.xml"/><Relationship Id="rId1" Type="http://schemas.openxmlformats.org/officeDocument/2006/relationships/slideLayout" Target="../slideLayouts/slideLayout7.xml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notesSlide" Target="../notesSlides/notesSlide46.xml"/><Relationship Id="rId1" Type="http://schemas.openxmlformats.org/officeDocument/2006/relationships/slideLayout" Target="../slideLayouts/slideLayout7.xml"/></Relationships>
</file>

<file path=ppt/slides/_rels/slide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notesSlide" Target="../notesSlides/notesSlide47.xml"/><Relationship Id="rId1" Type="http://schemas.openxmlformats.org/officeDocument/2006/relationships/slideLayout" Target="../slideLayouts/slideLayout7.xml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2" Type="http://schemas.openxmlformats.org/officeDocument/2006/relationships/notesSlide" Target="../notesSlides/notesSlide48.xml"/><Relationship Id="rId1" Type="http://schemas.openxmlformats.org/officeDocument/2006/relationships/slideLayout" Target="../slideLayouts/slideLayout7.xml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notesSlide" Target="../notesSlides/notesSlide49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5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notesSlide" Target="../notesSlides/notesSlide50.xml"/><Relationship Id="rId1" Type="http://schemas.openxmlformats.org/officeDocument/2006/relationships/slideLayout" Target="../slideLayouts/slideLayout7.xml"/></Relationships>
</file>

<file path=ppt/slides/_rels/slide5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notesSlide" Target="../notesSlides/notesSlide51.xml"/><Relationship Id="rId1" Type="http://schemas.openxmlformats.org/officeDocument/2006/relationships/slideLayout" Target="../slideLayouts/slideLayout7.xml"/></Relationships>
</file>

<file path=ppt/slides/_rels/slide5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notesSlide" Target="../notesSlides/notesSlide52.xml"/><Relationship Id="rId1" Type="http://schemas.openxmlformats.org/officeDocument/2006/relationships/slideLayout" Target="../slideLayouts/slideLayout7.xml"/></Relationships>
</file>

<file path=ppt/slides/_rels/slide5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notesSlide" Target="../notesSlides/notesSlide53.xml"/><Relationship Id="rId1" Type="http://schemas.openxmlformats.org/officeDocument/2006/relationships/slideLayout" Target="../slideLayouts/slideLayout7.xml"/></Relationships>
</file>

<file path=ppt/slides/_rels/slide5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notesSlide" Target="../notesSlides/notesSlide54.xml"/><Relationship Id="rId1" Type="http://schemas.openxmlformats.org/officeDocument/2006/relationships/slideLayout" Target="../slideLayouts/slideLayout7.xml"/></Relationships>
</file>

<file path=ppt/slides/_rels/slide5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png"/><Relationship Id="rId2" Type="http://schemas.openxmlformats.org/officeDocument/2006/relationships/notesSlide" Target="../notesSlides/notesSlide5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1D6A96B-D3A0-0E6A-3E08-BAF7B5A9418D}"/>
              </a:ext>
            </a:extLst>
          </p:cNvPr>
          <p:cNvSpPr txBox="1"/>
          <p:nvPr/>
        </p:nvSpPr>
        <p:spPr>
          <a:xfrm flipH="1">
            <a:off x="360044" y="148138"/>
            <a:ext cx="90327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C8F427A3-9366-85FE-057B-5668D0BA6A8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20" b="3736"/>
          <a:stretch>
            <a:fillRect/>
          </a:stretch>
        </p:blipFill>
        <p:spPr>
          <a:xfrm>
            <a:off x="1819038" y="119262"/>
            <a:ext cx="7681096" cy="66273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773456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268BA12-B16C-16D1-9C3C-236F6A797214}"/>
              </a:ext>
            </a:extLst>
          </p:cNvPr>
          <p:cNvSpPr txBox="1"/>
          <p:nvPr/>
        </p:nvSpPr>
        <p:spPr>
          <a:xfrm flipH="1">
            <a:off x="360039" y="148138"/>
            <a:ext cx="1044217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3b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66312498-AC92-A717-80D7-234DD8A1F10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3965" y="1143000"/>
            <a:ext cx="11923462" cy="36086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41102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4FD898D2-C6BF-625F-9414-022725B5FD5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1127" y="686028"/>
            <a:ext cx="10829745" cy="5939719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77304A6-FA51-F6F0-BB79-049F401574BD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425274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A405616-C8CC-2B77-D8D5-A62BDBDDFDB1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245C8FD7-7437-AC66-75FC-052F519BE2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7357" y="661545"/>
            <a:ext cx="9122797" cy="61387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257082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F277C21-A2AE-1BF4-EF2D-C625B1A2BF3D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D1867299-6BFA-39BC-7DCF-26B3C9B2B7B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8225" y="761999"/>
            <a:ext cx="9122797" cy="59681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538138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85E0366-B62B-EDDD-C664-1CE78AB1F6EB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70E14EFD-7C2B-A7D7-38D2-9A02CC1F96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95788" y="148138"/>
            <a:ext cx="8905374" cy="64917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87659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85E0366-B62B-EDDD-C664-1CE78AB1F6EB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D87A17F2-FC77-7225-455F-39D543D458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3553" y="757989"/>
            <a:ext cx="10526132" cy="59025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769714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C9EDF7B-37E2-DF5C-ADC6-4B3E2B58F667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4f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39BFAFFF-799D-A1BC-22B0-AD986AFDD18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0342" y="824593"/>
            <a:ext cx="11611315" cy="52088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687871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E60C634-2E1C-64D4-57AF-743749F2F114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FCDE67D5-8AFC-1873-482F-D99C9FE37D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40" y="766009"/>
            <a:ext cx="11132523" cy="58952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2585747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E60C634-2E1C-64D4-57AF-743749F2F114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b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977844A3-29F6-BAA3-5870-3140B9AC5E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28800" y="120155"/>
            <a:ext cx="8508733" cy="6597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100817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45318CB-F1F5-BEC4-34DE-7224D1A4000B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c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EA482ECE-2EF6-5A90-5606-278593735D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9874" y="747071"/>
            <a:ext cx="11232251" cy="57356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51536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C55BDE6-0732-4938-E9EB-771E0B994F2F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2a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F0343336-B807-A096-97CD-90643114F32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76600" y="721094"/>
            <a:ext cx="9157185" cy="59123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774491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2DE3BDC-ED9A-1A01-CF21-00F40D7279A1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d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2FD1D77A-9278-DDCB-C7D5-9AF523D30A0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60020" y="701841"/>
            <a:ext cx="10052808" cy="60839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631163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E3BA8B2-9F06-8485-CFB9-3AAC253865BA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e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B7021223-5BC0-D9A3-73CB-6FE210ACD0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2901" y="674571"/>
            <a:ext cx="9406388" cy="60485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300542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0083393-3F9C-C7BD-D0B8-A46C2189C1BC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f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6058AE83-6758-D65F-4F8E-A4C30454F7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6882" y="720289"/>
            <a:ext cx="10157159" cy="5955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215465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88F17CD-EF3E-B1AB-3D83-B663A31B9AF6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5g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CC1A881E-8B7B-689B-2E25-3ABAA3A930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41" y="859971"/>
            <a:ext cx="11461594" cy="49856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371676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10E50A88-E963-F1F8-EB3F-1FBEE90432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41" y="1003433"/>
            <a:ext cx="11611483" cy="5050858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68B8358-D65B-84CD-0E54-6EE6A2D67804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6a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539284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73F62E3-2D83-7414-6481-461DDB99005E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6b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2212F700-F402-E712-373B-0722C37380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7716" y="609803"/>
            <a:ext cx="10025971" cy="60677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682554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E60C634-2E1C-64D4-57AF-743749F2F114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6c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FCA2AAFE-34C7-5651-D8E7-D857D78F23E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40" y="907983"/>
            <a:ext cx="11637665" cy="55024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8667822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626BD8E-87D1-920E-F300-7153B3C8A13B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6d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95B393AC-2E46-9C54-EF17-A6618DE168A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3296" y="794129"/>
            <a:ext cx="10786014" cy="59157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7457153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E9D4BCA-A51D-F4C0-9743-B093765D3AD6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6e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C69E01AB-C9BF-95FE-719C-26747354323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40" y="1126671"/>
            <a:ext cx="11559609" cy="39351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528446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F9DB16F2-1989-0ED8-4C3C-3770FE4B0F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40" y="945682"/>
            <a:ext cx="11522971" cy="5012356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74C60D9-1550-CA3B-229A-BC7C9978D069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7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92659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43F7C62-200D-1DE2-9532-A0C3DA79598C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2b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23F7E5F4-4E11-270E-CFC3-92A11A08DB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73179" y="148137"/>
            <a:ext cx="8292249" cy="65250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1806670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EC25414-E882-FEF4-CC6D-693149FC4D37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7b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557B1598-3641-97F1-A5D5-383F2AD0E6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7716" y="609803"/>
            <a:ext cx="10054847" cy="60852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5884715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E60C634-2E1C-64D4-57AF-743749F2F114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7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430F8C6B-E008-28D7-48D1-7A1D0AA6092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41" y="927232"/>
            <a:ext cx="11698740" cy="55313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6548737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BFB63FF-44E3-07E8-E770-898C70553FA6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C2407787-A796-A88B-45F9-F6A354A136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2921" y="785261"/>
            <a:ext cx="10997770" cy="58238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8983554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201BCFE-BEE0-1F62-EBE8-096E9406B3ED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e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33CA0C9D-B889-E9F7-3F81-1F728A1D387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40" y="1202872"/>
            <a:ext cx="11545499" cy="37120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3565748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62966749-9820-831F-B0C3-ED61CC1F69F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40" y="984182"/>
            <a:ext cx="11545097" cy="5021981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06978FC-DEF6-069B-B8C9-A6EBDE5862E5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8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8014878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1F06D8D-0B40-F1D4-EB5F-8BBD08CCD6BA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8b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DCB5356B-37A7-30EB-F7D2-AE2CDC3DDFD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7716" y="609803"/>
            <a:ext cx="10054847" cy="60852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3797259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E60C634-2E1C-64D4-57AF-743749F2F114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8c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B5D75D26-40E0-CB47-C419-D6BE05DE1E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3041" y="859857"/>
            <a:ext cx="11698738" cy="55313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3491443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4BC1E52-B52D-1EC8-A614-15D9ADB817D4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8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3401D3E2-8E4E-796C-A238-DDC8C8AFE0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40" y="804511"/>
            <a:ext cx="11132523" cy="58952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2690677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8E848E2-F32C-53B9-59BA-8CD657A4429D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8e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5D66450F-0586-AEE3-25A2-D0C108C5CB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41" y="1317171"/>
            <a:ext cx="11596290" cy="37283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4767405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8B3978F-8E04-EBEF-510E-B3811784C6FB}"/>
              </a:ext>
            </a:extLst>
          </p:cNvPr>
          <p:cNvSpPr txBox="1"/>
          <p:nvPr/>
        </p:nvSpPr>
        <p:spPr>
          <a:xfrm flipH="1">
            <a:off x="360041" y="148138"/>
            <a:ext cx="1000128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9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D893B250-2D21-0F31-B34A-9CE4E3D325F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0527" y="638678"/>
            <a:ext cx="10952958" cy="59931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47408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0DAD33B-2F11-B50A-104D-DEE4AEB0B2B3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2c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AAB4B3DB-FF4B-EC6F-6E60-9C46E704F3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0628" y="649537"/>
            <a:ext cx="9750743" cy="60988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4313983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B59DEF6-DA98-C749-6E9E-643AFC098B63}"/>
              </a:ext>
            </a:extLst>
          </p:cNvPr>
          <p:cNvSpPr txBox="1"/>
          <p:nvPr/>
        </p:nvSpPr>
        <p:spPr>
          <a:xfrm flipH="1">
            <a:off x="360041" y="148138"/>
            <a:ext cx="1000128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9b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EB0AA8AD-E9E2-40E6-C490-E4FE55B6902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6251" y="1088457"/>
            <a:ext cx="11425994" cy="47540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3319560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5AA797F-5380-531D-8D6F-E06E83721609}"/>
              </a:ext>
            </a:extLst>
          </p:cNvPr>
          <p:cNvSpPr txBox="1"/>
          <p:nvPr/>
        </p:nvSpPr>
        <p:spPr>
          <a:xfrm flipH="1">
            <a:off x="360041" y="148138"/>
            <a:ext cx="1000128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9c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D3AF45EB-175B-1989-37D1-996CFC3D4B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3039" y="955307"/>
            <a:ext cx="11276902" cy="51185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4889435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848A0F4-88CC-48BF-5528-1235012E2666}"/>
              </a:ext>
            </a:extLst>
          </p:cNvPr>
          <p:cNvSpPr txBox="1"/>
          <p:nvPr/>
        </p:nvSpPr>
        <p:spPr>
          <a:xfrm flipH="1">
            <a:off x="360041" y="148138"/>
            <a:ext cx="1000128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9d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78C29EF0-CAAC-0334-2850-FDE7C1472E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108" y="1360714"/>
            <a:ext cx="11961317" cy="3619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8792867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CE83258-A6FC-0870-4494-76ACE1E79D4A}"/>
              </a:ext>
            </a:extLst>
          </p:cNvPr>
          <p:cNvSpPr txBox="1"/>
          <p:nvPr/>
        </p:nvSpPr>
        <p:spPr>
          <a:xfrm flipH="1">
            <a:off x="360040" y="148138"/>
            <a:ext cx="1112624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0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D23763B3-85D6-8D24-326B-63479C0A15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7795" y="774293"/>
            <a:ext cx="11276409" cy="55800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2278525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4470D16-10BA-94C3-D4BA-EC708222AFC7}"/>
              </a:ext>
            </a:extLst>
          </p:cNvPr>
          <p:cNvSpPr txBox="1"/>
          <p:nvPr/>
        </p:nvSpPr>
        <p:spPr>
          <a:xfrm flipH="1">
            <a:off x="360039" y="148138"/>
            <a:ext cx="1199253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0b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2FB6CD33-E4DB-E9E7-ACA1-988BEE8FD6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39" y="767614"/>
            <a:ext cx="10940020" cy="59808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8707166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CBA1D53-9F38-F890-946B-78F6D9A47BCD}"/>
              </a:ext>
            </a:extLst>
          </p:cNvPr>
          <p:cNvSpPr txBox="1"/>
          <p:nvPr/>
        </p:nvSpPr>
        <p:spPr>
          <a:xfrm flipH="1">
            <a:off x="360040" y="148138"/>
            <a:ext cx="1131875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0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0CEAB2EA-4E83-5807-4A6C-45EAEA6F18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40" y="737135"/>
            <a:ext cx="11261638" cy="57791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09775499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B691D83-A95A-FD37-69AA-40F35F678240}"/>
              </a:ext>
            </a:extLst>
          </p:cNvPr>
          <p:cNvSpPr txBox="1"/>
          <p:nvPr/>
        </p:nvSpPr>
        <p:spPr>
          <a:xfrm flipH="1">
            <a:off x="360040" y="148138"/>
            <a:ext cx="118962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0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EF8449B3-9DD7-74EC-E386-BC1304195F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0790" y="937660"/>
            <a:ext cx="11332668" cy="53572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1357251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B691D83-A95A-FD37-69AA-40F35F678240}"/>
              </a:ext>
            </a:extLst>
          </p:cNvPr>
          <p:cNvSpPr txBox="1"/>
          <p:nvPr/>
        </p:nvSpPr>
        <p:spPr>
          <a:xfrm flipH="1">
            <a:off x="360040" y="148138"/>
            <a:ext cx="1151125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0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6EF8E2E9-69F2-1181-A163-08EA6E29CBE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40" y="795688"/>
            <a:ext cx="11276903" cy="59258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6346362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5ECB517-9810-1B30-8181-E6D699444AA8}"/>
              </a:ext>
            </a:extLst>
          </p:cNvPr>
          <p:cNvSpPr txBox="1"/>
          <p:nvPr/>
        </p:nvSpPr>
        <p:spPr>
          <a:xfrm flipH="1">
            <a:off x="360040" y="148138"/>
            <a:ext cx="1151125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0f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4CC6C2FD-B8DF-A1F2-00F8-B0D75CDC43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3080" y="936173"/>
            <a:ext cx="11905875" cy="47461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1095263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30D50D8-A3C4-ECE6-BBC8-757BEE5BB85F}"/>
              </a:ext>
            </a:extLst>
          </p:cNvPr>
          <p:cNvSpPr txBox="1"/>
          <p:nvPr/>
        </p:nvSpPr>
        <p:spPr>
          <a:xfrm flipH="1">
            <a:off x="360040" y="148138"/>
            <a:ext cx="118000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1a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9E5F1D11-CDC2-FBE0-91CF-EE8DC73089D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62425" y="815205"/>
            <a:ext cx="8667149" cy="57780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96630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DB6FCDF-AB0B-2355-0444-8821314D63C3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2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FFB90729-09F8-6EC5-3D78-F53C2B5C21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0554" y="749164"/>
            <a:ext cx="9322974" cy="58312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265224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30D50D8-A3C4-ECE6-BBC8-757BEE5BB85F}"/>
              </a:ext>
            </a:extLst>
          </p:cNvPr>
          <p:cNvSpPr txBox="1"/>
          <p:nvPr/>
        </p:nvSpPr>
        <p:spPr>
          <a:xfrm flipH="1">
            <a:off x="360040" y="148138"/>
            <a:ext cx="118000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1b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1B5EC421-4832-0FF3-D901-7547EFB60E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67301" y="744621"/>
            <a:ext cx="8893743" cy="59291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7294172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30D50D8-A3C4-ECE6-BBC8-757BEE5BB85F}"/>
              </a:ext>
            </a:extLst>
          </p:cNvPr>
          <p:cNvSpPr txBox="1"/>
          <p:nvPr/>
        </p:nvSpPr>
        <p:spPr>
          <a:xfrm flipH="1">
            <a:off x="360040" y="148138"/>
            <a:ext cx="118000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1c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BDD0B229-B631-FCC6-B3ED-DC1B223B60A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67301" y="629117"/>
            <a:ext cx="9076623" cy="60510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5312277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30D50D8-A3C4-ECE6-BBC8-757BEE5BB85F}"/>
              </a:ext>
            </a:extLst>
          </p:cNvPr>
          <p:cNvSpPr txBox="1"/>
          <p:nvPr/>
        </p:nvSpPr>
        <p:spPr>
          <a:xfrm flipH="1">
            <a:off x="360040" y="148138"/>
            <a:ext cx="118000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1d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6777F162-9ECE-AA7A-8A6B-8721E21F2F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59957" y="782854"/>
            <a:ext cx="8966334" cy="59775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2433814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30D50D8-A3C4-ECE6-BBC8-757BEE5BB85F}"/>
              </a:ext>
            </a:extLst>
          </p:cNvPr>
          <p:cNvSpPr txBox="1"/>
          <p:nvPr/>
        </p:nvSpPr>
        <p:spPr>
          <a:xfrm flipH="1">
            <a:off x="360040" y="148138"/>
            <a:ext cx="118000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1e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2EA4195D-D79A-22F9-1655-29871458CD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61423" y="539281"/>
            <a:ext cx="9490510" cy="6327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8484319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30D50D8-A3C4-ECE6-BBC8-757BEE5BB85F}"/>
              </a:ext>
            </a:extLst>
          </p:cNvPr>
          <p:cNvSpPr txBox="1"/>
          <p:nvPr/>
        </p:nvSpPr>
        <p:spPr>
          <a:xfrm flipH="1">
            <a:off x="360040" y="148138"/>
            <a:ext cx="118000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1f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8F948D23-B6DC-756B-C6F5-4732BABE459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67301" y="609867"/>
            <a:ext cx="9221002" cy="61473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1702546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30D50D8-A3C4-ECE6-BBC8-757BEE5BB85F}"/>
              </a:ext>
            </a:extLst>
          </p:cNvPr>
          <p:cNvSpPr txBox="1"/>
          <p:nvPr/>
        </p:nvSpPr>
        <p:spPr>
          <a:xfrm flipH="1">
            <a:off x="360040" y="148138"/>
            <a:ext cx="118000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11g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B0E2EE10-371A-3242-A3BD-E6E1E3C300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48051" y="597033"/>
            <a:ext cx="9365381" cy="62435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12192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43F7C62-200D-1DE2-9532-A0C3DA79598C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2e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0B1AE32C-0E6B-723B-38D4-F09CFB5EB0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5666" y="708258"/>
            <a:ext cx="10482262" cy="59218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58967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43F7C62-200D-1DE2-9532-A0C3DA79598C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2f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25EF4848-204A-8F7B-2E57-424AFEE073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6668" y="812532"/>
            <a:ext cx="10863016" cy="56986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50867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F0C570F3-C78C-6443-0460-81EFB6F463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4725" y="968828"/>
            <a:ext cx="11612009" cy="5154385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6C4E97E-8068-59D6-EE06-17B667DA5FDE}"/>
              </a:ext>
            </a:extLst>
          </p:cNvPr>
          <p:cNvSpPr txBox="1"/>
          <p:nvPr/>
        </p:nvSpPr>
        <p:spPr>
          <a:xfrm flipH="1">
            <a:off x="360041" y="148138"/>
            <a:ext cx="101637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2g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485423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667F319-9233-8D55-4A27-BA840A83507E}"/>
              </a:ext>
            </a:extLst>
          </p:cNvPr>
          <p:cNvSpPr txBox="1"/>
          <p:nvPr/>
        </p:nvSpPr>
        <p:spPr>
          <a:xfrm flipH="1">
            <a:off x="360039" y="148138"/>
            <a:ext cx="1044217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3a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224DDCD7-3C86-F6A1-4E58-6C03FEC569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41" y="882899"/>
            <a:ext cx="11539311" cy="51221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72388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04</TotalTime>
  <Words>703</Words>
  <Application>Microsoft Office PowerPoint</Application>
  <PresentationFormat>ワイド画面</PresentationFormat>
  <Paragraphs>164</Paragraphs>
  <Slides>55</Slides>
  <Notes>55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5</vt:i4>
      </vt:variant>
    </vt:vector>
  </HeadingPairs>
  <TitlesOfParts>
    <vt:vector size="62" baseType="lpstr">
      <vt:lpstr>游ゴシック</vt:lpstr>
      <vt:lpstr>游ゴシック Light</vt:lpstr>
      <vt:lpstr>游明朝</vt:lpstr>
      <vt:lpstr>Arial</vt:lpstr>
      <vt:lpstr>Segoe UI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松井 亮太</dc:creator>
  <cp:lastModifiedBy>亮太 松井</cp:lastModifiedBy>
  <cp:revision>16</cp:revision>
  <dcterms:created xsi:type="dcterms:W3CDTF">2022-03-24T08:04:18Z</dcterms:created>
  <dcterms:modified xsi:type="dcterms:W3CDTF">2025-11-08T00:52:40Z</dcterms:modified>
</cp:coreProperties>
</file>